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B4BBE5B-7390-7C3F-9594-2FA978626686}"/>
              </a:ext>
            </a:extLst>
          </p:cNvPr>
          <p:cNvSpPr txBox="1"/>
          <p:nvPr/>
        </p:nvSpPr>
        <p:spPr>
          <a:xfrm>
            <a:off x="152584" y="5402169"/>
            <a:ext cx="833352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Mov. S7. Tracking when an animal exits off-screen.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ne marmoset exits the screen at the third second of the video. After exiting, it accurately tracked other marmosets and did not misidentify anything such as a ball or hammock.</a:t>
            </a:r>
          </a:p>
        </p:txBody>
      </p:sp>
      <p:pic>
        <p:nvPicPr>
          <p:cNvPr id="4" name="media8_">
            <a:hlinkClick r:id="" action="ppaction://media"/>
            <a:extLst>
              <a:ext uri="{FF2B5EF4-FFF2-40B4-BE49-F238E27FC236}">
                <a16:creationId xmlns:a16="http://schemas.microsoft.com/office/drawing/2014/main" id="{7728CAFE-1152-E12B-857C-60E9DEC0D7A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3204" t="7556" b="3762"/>
          <a:stretch/>
        </p:blipFill>
        <p:spPr>
          <a:xfrm>
            <a:off x="146474" y="478465"/>
            <a:ext cx="8851051" cy="4561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928420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3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5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7</cp:revision>
  <dcterms:created xsi:type="dcterms:W3CDTF">2023-07-18T01:28:01Z</dcterms:created>
  <dcterms:modified xsi:type="dcterms:W3CDTF">2023-12-05T08:06:26Z</dcterms:modified>
</cp:coreProperties>
</file>